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8331A-5FF2-404D-8496-DF48B3EE50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D34C5-5700-4541-9A1C-54BC6AD840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9E986-D307-4446-AE03-9C785EBA9A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F9786-BFDD-481F-B5F9-92DF662D81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E45FA-875C-445D-9094-E856DDDFF9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126B1-1FAC-42D8-A17A-0A861731B9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66F9A-4E26-407C-833F-55E50108F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E0DC6-F455-4CE8-90D7-A84006DCA0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F0A24-9632-47F3-8788-99C6734C61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87850-3561-47B1-B89D-2A191A4CD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72E6A-5ED4-4A52-97C0-EFC665F22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A1680-E239-4151-B8F0-F8412FAE88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59BA12-00C4-4D58-A035-692E86F626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84040" y="281160"/>
            <a:ext cx="899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S1 Table. Functional gene grouping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3"/>
          <p:cNvSpPr/>
          <p:nvPr/>
        </p:nvSpPr>
        <p:spPr>
          <a:xfrm>
            <a:off x="284040" y="685800"/>
            <a:ext cx="8305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5"/>
          <p:cNvSpPr/>
          <p:nvPr/>
        </p:nvSpPr>
        <p:spPr>
          <a:xfrm>
            <a:off x="284040" y="5257800"/>
            <a:ext cx="8305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52360" y="692280"/>
            <a:ext cx="8305920" cy="483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OPTOS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 ABL, BRCA1, CIDIA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IP6K3,  PCBP4, AIFM1 (PDCD8), PPP1R15A, RAD21, p53, p7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ARRES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CHK1, CHK2, DDIT3 (CHOP)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GTSE1, HUS1, MAP2K6, MAPK12, PCBP4, PPP1R15A, RAD17, RAD9A, SESN1, ZAK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CHECK POIN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TR, BRCA1, FANCG, NBN (NBS1), RAD1, RBBBP8, SMC1A(SMC1L1), p5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MAGED DNA BINDIN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NKRD17, BRCA1, DDB1, DMC1, ERCC1, FANCG, FEN1, MPG, MSH2, MSH3, N4BP2, NBN (NBS1), OGG1, PMS2P3 (PMS2L9), PNKP, RAD1, RAD18, RAD51, RAD51B, REV1 (REV1L). SEMA4A, XPA, XPC, XRCC1, XRCC2, XRCC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CLEOTID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DDB1, ERCC1, ERCC2 (XPD), LIG1, NTHL1, OGG1, PCNA, PNKP, RPA1,  p53, XPA, XP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S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, MUTYH, NTHL1, OGG1, UNG. APEX1, MBD4, M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SMATCH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BL1, ANKRD17, EXO1, MLH1, MLH3, MSH2, MSH3, MUTYH, N4BP2, PMS1, PMS2, PMS2P3 (PMS2L9), p73, TREX1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UBLE STRAND BREAK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CIB1, FEN1, XRCC6 (G22P1), XRCC6BP1 (KUB3), MRE11A, MNN(NBS1), PRKDC, RAD21, RAD50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GENES RELATED TO DNA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TM, ATRX, BTG2, CCNH, CDK7, CRY1, ERCC2 (XPD), GTF2H1, GTF2H2, IGHMBP2, LIG1, MNAT1, PCNA, RPA1, SUMO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"/>
          <p:cNvSpPr/>
          <p:nvPr/>
        </p:nvSpPr>
        <p:spPr>
          <a:xfrm>
            <a:off x="262080" y="5283360"/>
            <a:ext cx="8881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the relative expression of 84 DNA damage related genes involved in apoptosis (Table 1), cell cyc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Table 2), and DNA damage repair (Table 3) was characterized with the human DNA damage signaling pathwa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CR arra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15T17:47:07Z</dcterms:created>
  <dc:creator>Happy family</dc:creator>
  <dc:description/>
  <dc:language>en-US</dc:language>
  <cp:lastModifiedBy>Microsoft account</cp:lastModifiedBy>
  <dcterms:modified xsi:type="dcterms:W3CDTF">2016-07-18T14:09:29Z</dcterms:modified>
  <cp:revision>4</cp:revision>
  <dc:subject/>
  <dc:title>Slide 1</dc:title>
</cp:coreProperties>
</file>